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25199975" cy="18000663"/>
  <p:notesSz cx="7099300" cy="10234613"/>
  <p:defaultTextStyle>
    <a:defPPr>
      <a:defRPr lang="es-ES"/>
    </a:defPPr>
    <a:lvl1pPr marL="0" algn="l" defTabSz="2312953" rtl="0" eaLnBrk="1" latinLnBrk="0" hangingPunct="1">
      <a:defRPr sz="4552" kern="1200">
        <a:solidFill>
          <a:schemeClr val="tx1"/>
        </a:solidFill>
        <a:latin typeface="+mn-lt"/>
        <a:ea typeface="+mn-ea"/>
        <a:cs typeface="+mn-cs"/>
      </a:defRPr>
    </a:lvl1pPr>
    <a:lvl2pPr marL="1156475" algn="l" defTabSz="2312953" rtl="0" eaLnBrk="1" latinLnBrk="0" hangingPunct="1">
      <a:defRPr sz="4552" kern="1200">
        <a:solidFill>
          <a:schemeClr val="tx1"/>
        </a:solidFill>
        <a:latin typeface="+mn-lt"/>
        <a:ea typeface="+mn-ea"/>
        <a:cs typeface="+mn-cs"/>
      </a:defRPr>
    </a:lvl2pPr>
    <a:lvl3pPr marL="2312953" algn="l" defTabSz="2312953" rtl="0" eaLnBrk="1" latinLnBrk="0" hangingPunct="1">
      <a:defRPr sz="4552" kern="1200">
        <a:solidFill>
          <a:schemeClr val="tx1"/>
        </a:solidFill>
        <a:latin typeface="+mn-lt"/>
        <a:ea typeface="+mn-ea"/>
        <a:cs typeface="+mn-cs"/>
      </a:defRPr>
    </a:lvl3pPr>
    <a:lvl4pPr marL="3469428" algn="l" defTabSz="2312953" rtl="0" eaLnBrk="1" latinLnBrk="0" hangingPunct="1">
      <a:defRPr sz="4552" kern="1200">
        <a:solidFill>
          <a:schemeClr val="tx1"/>
        </a:solidFill>
        <a:latin typeface="+mn-lt"/>
        <a:ea typeface="+mn-ea"/>
        <a:cs typeface="+mn-cs"/>
      </a:defRPr>
    </a:lvl4pPr>
    <a:lvl5pPr marL="4625906" algn="l" defTabSz="2312953" rtl="0" eaLnBrk="1" latinLnBrk="0" hangingPunct="1">
      <a:defRPr sz="4552" kern="1200">
        <a:solidFill>
          <a:schemeClr val="tx1"/>
        </a:solidFill>
        <a:latin typeface="+mn-lt"/>
        <a:ea typeface="+mn-ea"/>
        <a:cs typeface="+mn-cs"/>
      </a:defRPr>
    </a:lvl5pPr>
    <a:lvl6pPr marL="5782383" algn="l" defTabSz="2312953" rtl="0" eaLnBrk="1" latinLnBrk="0" hangingPunct="1">
      <a:defRPr sz="4552" kern="1200">
        <a:solidFill>
          <a:schemeClr val="tx1"/>
        </a:solidFill>
        <a:latin typeface="+mn-lt"/>
        <a:ea typeface="+mn-ea"/>
        <a:cs typeface="+mn-cs"/>
      </a:defRPr>
    </a:lvl6pPr>
    <a:lvl7pPr marL="6938857" algn="l" defTabSz="2312953" rtl="0" eaLnBrk="1" latinLnBrk="0" hangingPunct="1">
      <a:defRPr sz="4552" kern="1200">
        <a:solidFill>
          <a:schemeClr val="tx1"/>
        </a:solidFill>
        <a:latin typeface="+mn-lt"/>
        <a:ea typeface="+mn-ea"/>
        <a:cs typeface="+mn-cs"/>
      </a:defRPr>
    </a:lvl7pPr>
    <a:lvl8pPr marL="8095333" algn="l" defTabSz="2312953" rtl="0" eaLnBrk="1" latinLnBrk="0" hangingPunct="1">
      <a:defRPr sz="4552" kern="1200">
        <a:solidFill>
          <a:schemeClr val="tx1"/>
        </a:solidFill>
        <a:latin typeface="+mn-lt"/>
        <a:ea typeface="+mn-ea"/>
        <a:cs typeface="+mn-cs"/>
      </a:defRPr>
    </a:lvl8pPr>
    <a:lvl9pPr marL="9251810" algn="l" defTabSz="2312953" rtl="0" eaLnBrk="1" latinLnBrk="0" hangingPunct="1">
      <a:defRPr sz="455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793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elen" initials="B" lastIdx="3" clrIdx="0">
    <p:extLst>
      <p:ext uri="{19B8F6BF-5375-455C-9EA6-DF929625EA0E}">
        <p15:presenceInfo xmlns:p15="http://schemas.microsoft.com/office/powerpoint/2012/main" userId="Bele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7F9A5"/>
    <a:srgbClr val="D9FED6"/>
    <a:srgbClr val="FBFDF5"/>
    <a:srgbClr val="F6FBEB"/>
    <a:srgbClr val="CC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00" autoAdjust="0"/>
    <p:restoredTop sz="94660"/>
  </p:normalViewPr>
  <p:slideViewPr>
    <p:cSldViewPr>
      <p:cViewPr varScale="1">
        <p:scale>
          <a:sx n="45" d="100"/>
          <a:sy n="45" d="100"/>
        </p:scale>
        <p:origin x="3084" y="48"/>
      </p:cViewPr>
      <p:guideLst>
        <p:guide orient="horz" pos="5670"/>
        <p:guide pos="79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1889999" y="5591878"/>
            <a:ext cx="21419978" cy="385847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3780001" y="10200383"/>
            <a:ext cx="17639983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6799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3598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0398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67197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3997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0796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17596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34395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4315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2455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4745564" y="4541840"/>
            <a:ext cx="20089980" cy="9676189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466879" y="4541840"/>
            <a:ext cx="59858690" cy="9676189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8260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9811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990626" y="11567096"/>
            <a:ext cx="21419978" cy="3575132"/>
          </a:xfrm>
        </p:spPr>
        <p:txBody>
          <a:bodyPr anchor="t"/>
          <a:lstStyle>
            <a:lvl1pPr algn="l">
              <a:defRPr sz="14698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1990626" y="7629453"/>
            <a:ext cx="21419978" cy="3937645"/>
          </a:xfrm>
        </p:spPr>
        <p:txBody>
          <a:bodyPr anchor="b"/>
          <a:lstStyle>
            <a:lvl1pPr marL="0" indent="0">
              <a:buNone/>
              <a:defRPr sz="7387">
                <a:solidFill>
                  <a:schemeClr val="tx1">
                    <a:tint val="75000"/>
                  </a:schemeClr>
                </a:solidFill>
              </a:defRPr>
            </a:lvl1pPr>
            <a:lvl2pPr marL="1679947" indent="0">
              <a:buNone/>
              <a:defRPr sz="6608">
                <a:solidFill>
                  <a:schemeClr val="tx1">
                    <a:tint val="75000"/>
                  </a:schemeClr>
                </a:solidFill>
              </a:defRPr>
            </a:lvl2pPr>
            <a:lvl3pPr marL="3359896" indent="0">
              <a:buNone/>
              <a:defRPr sz="5910">
                <a:solidFill>
                  <a:schemeClr val="tx1">
                    <a:tint val="75000"/>
                  </a:schemeClr>
                </a:solidFill>
              </a:defRPr>
            </a:lvl3pPr>
            <a:lvl4pPr marL="5039842" indent="0">
              <a:buNone/>
              <a:defRPr sz="5133">
                <a:solidFill>
                  <a:schemeClr val="tx1">
                    <a:tint val="75000"/>
                  </a:schemeClr>
                </a:solidFill>
              </a:defRPr>
            </a:lvl4pPr>
            <a:lvl5pPr marL="6719789" indent="0">
              <a:buNone/>
              <a:defRPr sz="5133">
                <a:solidFill>
                  <a:schemeClr val="tx1">
                    <a:tint val="75000"/>
                  </a:schemeClr>
                </a:solidFill>
              </a:defRPr>
            </a:lvl5pPr>
            <a:lvl6pPr marL="8399737" indent="0">
              <a:buNone/>
              <a:defRPr sz="5133">
                <a:solidFill>
                  <a:schemeClr val="tx1">
                    <a:tint val="75000"/>
                  </a:schemeClr>
                </a:solidFill>
              </a:defRPr>
            </a:lvl6pPr>
            <a:lvl7pPr marL="10079683" indent="0">
              <a:buNone/>
              <a:defRPr sz="5133">
                <a:solidFill>
                  <a:schemeClr val="tx1">
                    <a:tint val="75000"/>
                  </a:schemeClr>
                </a:solidFill>
              </a:defRPr>
            </a:lvl7pPr>
            <a:lvl8pPr marL="11759632" indent="0">
              <a:buNone/>
              <a:defRPr sz="5133">
                <a:solidFill>
                  <a:schemeClr val="tx1">
                    <a:tint val="75000"/>
                  </a:schemeClr>
                </a:solidFill>
              </a:defRPr>
            </a:lvl8pPr>
            <a:lvl9pPr marL="13439576" indent="0">
              <a:buNone/>
              <a:defRPr sz="5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132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466874" y="26459310"/>
            <a:ext cx="39974334" cy="74844424"/>
          </a:xfrm>
        </p:spPr>
        <p:txBody>
          <a:bodyPr/>
          <a:lstStyle>
            <a:lvl1pPr>
              <a:defRPr sz="10264"/>
            </a:lvl1pPr>
            <a:lvl2pPr>
              <a:defRPr sz="8787"/>
            </a:lvl2pPr>
            <a:lvl3pPr>
              <a:defRPr sz="7387"/>
            </a:lvl3pPr>
            <a:lvl4pPr>
              <a:defRPr sz="6608"/>
            </a:lvl4pPr>
            <a:lvl5pPr>
              <a:defRPr sz="6608"/>
            </a:lvl5pPr>
            <a:lvl6pPr>
              <a:defRPr sz="6608"/>
            </a:lvl6pPr>
            <a:lvl7pPr>
              <a:defRPr sz="6608"/>
            </a:lvl7pPr>
            <a:lvl8pPr>
              <a:defRPr sz="6608"/>
            </a:lvl8pPr>
            <a:lvl9pPr>
              <a:defRPr sz="6608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4861212" y="26459310"/>
            <a:ext cx="39974337" cy="74844424"/>
          </a:xfrm>
        </p:spPr>
        <p:txBody>
          <a:bodyPr/>
          <a:lstStyle>
            <a:lvl1pPr>
              <a:defRPr sz="10264"/>
            </a:lvl1pPr>
            <a:lvl2pPr>
              <a:defRPr sz="8787"/>
            </a:lvl2pPr>
            <a:lvl3pPr>
              <a:defRPr sz="7387"/>
            </a:lvl3pPr>
            <a:lvl4pPr>
              <a:defRPr sz="6608"/>
            </a:lvl4pPr>
            <a:lvl5pPr>
              <a:defRPr sz="6608"/>
            </a:lvl5pPr>
            <a:lvl6pPr>
              <a:defRPr sz="6608"/>
            </a:lvl6pPr>
            <a:lvl7pPr>
              <a:defRPr sz="6608"/>
            </a:lvl7pPr>
            <a:lvl8pPr>
              <a:defRPr sz="6608"/>
            </a:lvl8pPr>
            <a:lvl9pPr>
              <a:defRPr sz="6608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052609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259999" y="720865"/>
            <a:ext cx="22679978" cy="3000111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1260009" y="4029316"/>
            <a:ext cx="11134365" cy="1679228"/>
          </a:xfrm>
        </p:spPr>
        <p:txBody>
          <a:bodyPr anchor="b"/>
          <a:lstStyle>
            <a:lvl1pPr marL="0" indent="0">
              <a:buNone/>
              <a:defRPr sz="8787" b="1"/>
            </a:lvl1pPr>
            <a:lvl2pPr marL="1679947" indent="0">
              <a:buNone/>
              <a:defRPr sz="7387" b="1"/>
            </a:lvl2pPr>
            <a:lvl3pPr marL="3359896" indent="0">
              <a:buNone/>
              <a:defRPr sz="6608" b="1"/>
            </a:lvl3pPr>
            <a:lvl4pPr marL="5039842" indent="0">
              <a:buNone/>
              <a:defRPr sz="5910" b="1"/>
            </a:lvl4pPr>
            <a:lvl5pPr marL="6719789" indent="0">
              <a:buNone/>
              <a:defRPr sz="5910" b="1"/>
            </a:lvl5pPr>
            <a:lvl6pPr marL="8399737" indent="0">
              <a:buNone/>
              <a:defRPr sz="5910" b="1"/>
            </a:lvl6pPr>
            <a:lvl7pPr marL="10079683" indent="0">
              <a:buNone/>
              <a:defRPr sz="5910" b="1"/>
            </a:lvl7pPr>
            <a:lvl8pPr marL="11759632" indent="0">
              <a:buNone/>
              <a:defRPr sz="5910" b="1"/>
            </a:lvl8pPr>
            <a:lvl9pPr marL="13439576" indent="0">
              <a:buNone/>
              <a:defRPr sz="591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1260009" y="5708545"/>
            <a:ext cx="11134365" cy="10371217"/>
          </a:xfrm>
        </p:spPr>
        <p:txBody>
          <a:bodyPr/>
          <a:lstStyle>
            <a:lvl1pPr>
              <a:defRPr sz="8787"/>
            </a:lvl1pPr>
            <a:lvl2pPr>
              <a:defRPr sz="7387"/>
            </a:lvl2pPr>
            <a:lvl3pPr>
              <a:defRPr sz="6608"/>
            </a:lvl3pPr>
            <a:lvl4pPr>
              <a:defRPr sz="5910"/>
            </a:lvl4pPr>
            <a:lvl5pPr>
              <a:defRPr sz="5910"/>
            </a:lvl5pPr>
            <a:lvl6pPr>
              <a:defRPr sz="5910"/>
            </a:lvl6pPr>
            <a:lvl7pPr>
              <a:defRPr sz="5910"/>
            </a:lvl7pPr>
            <a:lvl8pPr>
              <a:defRPr sz="5910"/>
            </a:lvl8pPr>
            <a:lvl9pPr>
              <a:defRPr sz="591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12801247" y="4029316"/>
            <a:ext cx="11138738" cy="1679228"/>
          </a:xfrm>
        </p:spPr>
        <p:txBody>
          <a:bodyPr anchor="b"/>
          <a:lstStyle>
            <a:lvl1pPr marL="0" indent="0">
              <a:buNone/>
              <a:defRPr sz="8787" b="1"/>
            </a:lvl1pPr>
            <a:lvl2pPr marL="1679947" indent="0">
              <a:buNone/>
              <a:defRPr sz="7387" b="1"/>
            </a:lvl2pPr>
            <a:lvl3pPr marL="3359896" indent="0">
              <a:buNone/>
              <a:defRPr sz="6608" b="1"/>
            </a:lvl3pPr>
            <a:lvl4pPr marL="5039842" indent="0">
              <a:buNone/>
              <a:defRPr sz="5910" b="1"/>
            </a:lvl4pPr>
            <a:lvl5pPr marL="6719789" indent="0">
              <a:buNone/>
              <a:defRPr sz="5910" b="1"/>
            </a:lvl5pPr>
            <a:lvl6pPr marL="8399737" indent="0">
              <a:buNone/>
              <a:defRPr sz="5910" b="1"/>
            </a:lvl6pPr>
            <a:lvl7pPr marL="10079683" indent="0">
              <a:buNone/>
              <a:defRPr sz="5910" b="1"/>
            </a:lvl7pPr>
            <a:lvl8pPr marL="11759632" indent="0">
              <a:buNone/>
              <a:defRPr sz="5910" b="1"/>
            </a:lvl8pPr>
            <a:lvl9pPr marL="13439576" indent="0">
              <a:buNone/>
              <a:defRPr sz="591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12801247" y="5708545"/>
            <a:ext cx="11138738" cy="10371217"/>
          </a:xfrm>
        </p:spPr>
        <p:txBody>
          <a:bodyPr/>
          <a:lstStyle>
            <a:lvl1pPr>
              <a:defRPr sz="8787"/>
            </a:lvl1pPr>
            <a:lvl2pPr>
              <a:defRPr sz="7387"/>
            </a:lvl2pPr>
            <a:lvl3pPr>
              <a:defRPr sz="6608"/>
            </a:lvl3pPr>
            <a:lvl4pPr>
              <a:defRPr sz="5910"/>
            </a:lvl4pPr>
            <a:lvl5pPr>
              <a:defRPr sz="5910"/>
            </a:lvl5pPr>
            <a:lvl6pPr>
              <a:defRPr sz="5910"/>
            </a:lvl6pPr>
            <a:lvl7pPr>
              <a:defRPr sz="5910"/>
            </a:lvl7pPr>
            <a:lvl8pPr>
              <a:defRPr sz="5910"/>
            </a:lvl8pPr>
            <a:lvl9pPr>
              <a:defRPr sz="591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5458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7028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0235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260006" y="716697"/>
            <a:ext cx="8290619" cy="3050113"/>
          </a:xfrm>
        </p:spPr>
        <p:txBody>
          <a:bodyPr anchor="b"/>
          <a:lstStyle>
            <a:lvl1pPr algn="l">
              <a:defRPr sz="7387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9852493" y="716697"/>
            <a:ext cx="14087484" cy="15363068"/>
          </a:xfrm>
        </p:spPr>
        <p:txBody>
          <a:bodyPr/>
          <a:lstStyle>
            <a:lvl1pPr>
              <a:defRPr sz="11744"/>
            </a:lvl1pPr>
            <a:lvl2pPr>
              <a:defRPr sz="10264"/>
            </a:lvl2pPr>
            <a:lvl3pPr>
              <a:defRPr sz="8787"/>
            </a:lvl3pPr>
            <a:lvl4pPr>
              <a:defRPr sz="7387"/>
            </a:lvl4pPr>
            <a:lvl5pPr>
              <a:defRPr sz="7387"/>
            </a:lvl5pPr>
            <a:lvl6pPr>
              <a:defRPr sz="7387"/>
            </a:lvl6pPr>
            <a:lvl7pPr>
              <a:defRPr sz="7387"/>
            </a:lvl7pPr>
            <a:lvl8pPr>
              <a:defRPr sz="7387"/>
            </a:lvl8pPr>
            <a:lvl9pPr>
              <a:defRPr sz="7387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260006" y="3766810"/>
            <a:ext cx="8290619" cy="12312955"/>
          </a:xfrm>
        </p:spPr>
        <p:txBody>
          <a:bodyPr/>
          <a:lstStyle>
            <a:lvl1pPr marL="0" indent="0">
              <a:buNone/>
              <a:defRPr sz="5133"/>
            </a:lvl1pPr>
            <a:lvl2pPr marL="1679947" indent="0">
              <a:buNone/>
              <a:defRPr sz="4432"/>
            </a:lvl2pPr>
            <a:lvl3pPr marL="3359896" indent="0">
              <a:buNone/>
              <a:defRPr sz="3652"/>
            </a:lvl3pPr>
            <a:lvl4pPr marL="5039842" indent="0">
              <a:buNone/>
              <a:defRPr sz="3344"/>
            </a:lvl4pPr>
            <a:lvl5pPr marL="6719789" indent="0">
              <a:buNone/>
              <a:defRPr sz="3344"/>
            </a:lvl5pPr>
            <a:lvl6pPr marL="8399737" indent="0">
              <a:buNone/>
              <a:defRPr sz="3344"/>
            </a:lvl6pPr>
            <a:lvl7pPr marL="10079683" indent="0">
              <a:buNone/>
              <a:defRPr sz="3344"/>
            </a:lvl7pPr>
            <a:lvl8pPr marL="11759632" indent="0">
              <a:buNone/>
              <a:defRPr sz="3344"/>
            </a:lvl8pPr>
            <a:lvl9pPr marL="13439576" indent="0">
              <a:buNone/>
              <a:defRPr sz="3344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8702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39379" y="12600473"/>
            <a:ext cx="15119985" cy="1487556"/>
          </a:xfrm>
        </p:spPr>
        <p:txBody>
          <a:bodyPr anchor="b"/>
          <a:lstStyle>
            <a:lvl1pPr algn="l">
              <a:defRPr sz="7387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4939379" y="1608400"/>
            <a:ext cx="15119985" cy="10800398"/>
          </a:xfrm>
        </p:spPr>
        <p:txBody>
          <a:bodyPr/>
          <a:lstStyle>
            <a:lvl1pPr marL="0" indent="0">
              <a:buNone/>
              <a:defRPr sz="11744"/>
            </a:lvl1pPr>
            <a:lvl2pPr marL="1679947" indent="0">
              <a:buNone/>
              <a:defRPr sz="10264"/>
            </a:lvl2pPr>
            <a:lvl3pPr marL="3359896" indent="0">
              <a:buNone/>
              <a:defRPr sz="8787"/>
            </a:lvl3pPr>
            <a:lvl4pPr marL="5039842" indent="0">
              <a:buNone/>
              <a:defRPr sz="7387"/>
            </a:lvl4pPr>
            <a:lvl5pPr marL="6719789" indent="0">
              <a:buNone/>
              <a:defRPr sz="7387"/>
            </a:lvl5pPr>
            <a:lvl6pPr marL="8399737" indent="0">
              <a:buNone/>
              <a:defRPr sz="7387"/>
            </a:lvl6pPr>
            <a:lvl7pPr marL="10079683" indent="0">
              <a:buNone/>
              <a:defRPr sz="7387"/>
            </a:lvl7pPr>
            <a:lvl8pPr marL="11759632" indent="0">
              <a:buNone/>
              <a:defRPr sz="7387"/>
            </a:lvl8pPr>
            <a:lvl9pPr marL="13439576" indent="0">
              <a:buNone/>
              <a:defRPr sz="7387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939379" y="14088021"/>
            <a:ext cx="15119985" cy="2112576"/>
          </a:xfrm>
        </p:spPr>
        <p:txBody>
          <a:bodyPr/>
          <a:lstStyle>
            <a:lvl1pPr marL="0" indent="0">
              <a:buNone/>
              <a:defRPr sz="5133"/>
            </a:lvl1pPr>
            <a:lvl2pPr marL="1679947" indent="0">
              <a:buNone/>
              <a:defRPr sz="4432"/>
            </a:lvl2pPr>
            <a:lvl3pPr marL="3359896" indent="0">
              <a:buNone/>
              <a:defRPr sz="3652"/>
            </a:lvl3pPr>
            <a:lvl4pPr marL="5039842" indent="0">
              <a:buNone/>
              <a:defRPr sz="3344"/>
            </a:lvl4pPr>
            <a:lvl5pPr marL="6719789" indent="0">
              <a:buNone/>
              <a:defRPr sz="3344"/>
            </a:lvl5pPr>
            <a:lvl6pPr marL="8399737" indent="0">
              <a:buNone/>
              <a:defRPr sz="3344"/>
            </a:lvl6pPr>
            <a:lvl7pPr marL="10079683" indent="0">
              <a:buNone/>
              <a:defRPr sz="3344"/>
            </a:lvl7pPr>
            <a:lvl8pPr marL="11759632" indent="0">
              <a:buNone/>
              <a:defRPr sz="3344"/>
            </a:lvl8pPr>
            <a:lvl9pPr marL="13439576" indent="0">
              <a:buNone/>
              <a:defRPr sz="3344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3857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1259999" y="720865"/>
            <a:ext cx="22679978" cy="3000111"/>
          </a:xfrm>
          <a:prstGeom prst="rect">
            <a:avLst/>
          </a:prstGeom>
        </p:spPr>
        <p:txBody>
          <a:bodyPr vert="horz" lIns="432054" tIns="216027" rIns="432054" bIns="216027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1259999" y="4200158"/>
            <a:ext cx="22679978" cy="11879605"/>
          </a:xfrm>
          <a:prstGeom prst="rect">
            <a:avLst/>
          </a:prstGeom>
        </p:spPr>
        <p:txBody>
          <a:bodyPr vert="horz" lIns="432054" tIns="216027" rIns="432054" bIns="216027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1259999" y="16683953"/>
            <a:ext cx="5879994" cy="958369"/>
          </a:xfrm>
          <a:prstGeom prst="rect">
            <a:avLst/>
          </a:prstGeom>
        </p:spPr>
        <p:txBody>
          <a:bodyPr vert="horz" lIns="432054" tIns="216027" rIns="432054" bIns="216027" rtlCol="0" anchor="ctr"/>
          <a:lstStyle>
            <a:lvl1pPr algn="l">
              <a:defRPr sz="44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D890F1-31A4-41A6-986E-7B026C5EC7E5}" type="datetimeFigureOut">
              <a:rPr lang="es-ES" smtClean="0"/>
              <a:t>06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8609996" y="16683953"/>
            <a:ext cx="7979993" cy="958369"/>
          </a:xfrm>
          <a:prstGeom prst="rect">
            <a:avLst/>
          </a:prstGeom>
        </p:spPr>
        <p:txBody>
          <a:bodyPr vert="horz" lIns="432054" tIns="216027" rIns="432054" bIns="216027" rtlCol="0" anchor="ctr"/>
          <a:lstStyle>
            <a:lvl1pPr algn="ctr">
              <a:defRPr sz="44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18059983" y="16683953"/>
            <a:ext cx="5879994" cy="958369"/>
          </a:xfrm>
          <a:prstGeom prst="rect">
            <a:avLst/>
          </a:prstGeom>
        </p:spPr>
        <p:txBody>
          <a:bodyPr vert="horz" lIns="432054" tIns="216027" rIns="432054" bIns="216027" rtlCol="0" anchor="ctr"/>
          <a:lstStyle>
            <a:lvl1pPr algn="r">
              <a:defRPr sz="44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9ECF84-6F0E-4A70-BB05-3626B307DB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09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359896" rtl="0" eaLnBrk="1" latinLnBrk="0" hangingPunct="1">
        <a:spcBef>
          <a:spcPct val="0"/>
        </a:spcBef>
        <a:buNone/>
        <a:defRPr sz="161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59960" indent="-1259960" algn="l" defTabSz="3359896" rtl="0" eaLnBrk="1" latinLnBrk="0" hangingPunct="1">
        <a:spcBef>
          <a:spcPct val="20000"/>
        </a:spcBef>
        <a:buFont typeface="Arial" panose="020B0604020202020204" pitchFamily="34" charset="0"/>
        <a:buChar char="•"/>
        <a:defRPr sz="11744" kern="1200">
          <a:solidFill>
            <a:schemeClr val="tx1"/>
          </a:solidFill>
          <a:latin typeface="+mn-lt"/>
          <a:ea typeface="+mn-ea"/>
          <a:cs typeface="+mn-cs"/>
        </a:defRPr>
      </a:lvl1pPr>
      <a:lvl2pPr marL="2729914" indent="-1049967" algn="l" defTabSz="3359896" rtl="0" eaLnBrk="1" latinLnBrk="0" hangingPunct="1">
        <a:spcBef>
          <a:spcPct val="20000"/>
        </a:spcBef>
        <a:buFont typeface="Arial" panose="020B0604020202020204" pitchFamily="34" charset="0"/>
        <a:buChar char="–"/>
        <a:defRPr sz="10264" kern="1200">
          <a:solidFill>
            <a:schemeClr val="tx1"/>
          </a:solidFill>
          <a:latin typeface="+mn-lt"/>
          <a:ea typeface="+mn-ea"/>
          <a:cs typeface="+mn-cs"/>
        </a:defRPr>
      </a:lvl2pPr>
      <a:lvl3pPr marL="4199868" indent="-839974" algn="l" defTabSz="3359896" rtl="0" eaLnBrk="1" latinLnBrk="0" hangingPunct="1">
        <a:spcBef>
          <a:spcPct val="20000"/>
        </a:spcBef>
        <a:buFont typeface="Arial" panose="020B0604020202020204" pitchFamily="34" charset="0"/>
        <a:buChar char="•"/>
        <a:defRPr sz="8787" kern="1200">
          <a:solidFill>
            <a:schemeClr val="tx1"/>
          </a:solidFill>
          <a:latin typeface="+mn-lt"/>
          <a:ea typeface="+mn-ea"/>
          <a:cs typeface="+mn-cs"/>
        </a:defRPr>
      </a:lvl3pPr>
      <a:lvl4pPr marL="5879815" indent="-839974" algn="l" defTabSz="3359896" rtl="0" eaLnBrk="1" latinLnBrk="0" hangingPunct="1">
        <a:spcBef>
          <a:spcPct val="20000"/>
        </a:spcBef>
        <a:buFont typeface="Arial" panose="020B0604020202020204" pitchFamily="34" charset="0"/>
        <a:buChar char="–"/>
        <a:defRPr sz="7387" kern="1200">
          <a:solidFill>
            <a:schemeClr val="tx1"/>
          </a:solidFill>
          <a:latin typeface="+mn-lt"/>
          <a:ea typeface="+mn-ea"/>
          <a:cs typeface="+mn-cs"/>
        </a:defRPr>
      </a:lvl4pPr>
      <a:lvl5pPr marL="7559764" indent="-839974" algn="l" defTabSz="3359896" rtl="0" eaLnBrk="1" latinLnBrk="0" hangingPunct="1">
        <a:spcBef>
          <a:spcPct val="20000"/>
        </a:spcBef>
        <a:buFont typeface="Arial" panose="020B0604020202020204" pitchFamily="34" charset="0"/>
        <a:buChar char="»"/>
        <a:defRPr sz="7387" kern="1200">
          <a:solidFill>
            <a:schemeClr val="tx1"/>
          </a:solidFill>
          <a:latin typeface="+mn-lt"/>
          <a:ea typeface="+mn-ea"/>
          <a:cs typeface="+mn-cs"/>
        </a:defRPr>
      </a:lvl5pPr>
      <a:lvl6pPr marL="9239711" indent="-839974" algn="l" defTabSz="3359896" rtl="0" eaLnBrk="1" latinLnBrk="0" hangingPunct="1">
        <a:spcBef>
          <a:spcPct val="20000"/>
        </a:spcBef>
        <a:buFont typeface="Arial" panose="020B0604020202020204" pitchFamily="34" charset="0"/>
        <a:buChar char="•"/>
        <a:defRPr sz="7387" kern="1200">
          <a:solidFill>
            <a:schemeClr val="tx1"/>
          </a:solidFill>
          <a:latin typeface="+mn-lt"/>
          <a:ea typeface="+mn-ea"/>
          <a:cs typeface="+mn-cs"/>
        </a:defRPr>
      </a:lvl6pPr>
      <a:lvl7pPr marL="10919654" indent="-839974" algn="l" defTabSz="3359896" rtl="0" eaLnBrk="1" latinLnBrk="0" hangingPunct="1">
        <a:spcBef>
          <a:spcPct val="20000"/>
        </a:spcBef>
        <a:buFont typeface="Arial" panose="020B0604020202020204" pitchFamily="34" charset="0"/>
        <a:buChar char="•"/>
        <a:defRPr sz="73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604" indent="-839974" algn="l" defTabSz="3359896" rtl="0" eaLnBrk="1" latinLnBrk="0" hangingPunct="1">
        <a:spcBef>
          <a:spcPct val="20000"/>
        </a:spcBef>
        <a:buFont typeface="Arial" panose="020B0604020202020204" pitchFamily="34" charset="0"/>
        <a:buChar char="•"/>
        <a:defRPr sz="7387" kern="1200">
          <a:solidFill>
            <a:schemeClr val="tx1"/>
          </a:solidFill>
          <a:latin typeface="+mn-lt"/>
          <a:ea typeface="+mn-ea"/>
          <a:cs typeface="+mn-cs"/>
        </a:defRPr>
      </a:lvl8pPr>
      <a:lvl9pPr marL="14279551" indent="-839974" algn="l" defTabSz="3359896" rtl="0" eaLnBrk="1" latinLnBrk="0" hangingPunct="1">
        <a:spcBef>
          <a:spcPct val="20000"/>
        </a:spcBef>
        <a:buFont typeface="Arial" panose="020B0604020202020204" pitchFamily="34" charset="0"/>
        <a:buChar char="•"/>
        <a:defRPr sz="73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3359896" rtl="0" eaLnBrk="1" latinLnBrk="0" hangingPunct="1">
        <a:defRPr sz="6608" kern="1200">
          <a:solidFill>
            <a:schemeClr val="tx1"/>
          </a:solidFill>
          <a:latin typeface="+mn-lt"/>
          <a:ea typeface="+mn-ea"/>
          <a:cs typeface="+mn-cs"/>
        </a:defRPr>
      </a:lvl1pPr>
      <a:lvl2pPr marL="1679947" algn="l" defTabSz="3359896" rtl="0" eaLnBrk="1" latinLnBrk="0" hangingPunct="1">
        <a:defRPr sz="6608" kern="1200">
          <a:solidFill>
            <a:schemeClr val="tx1"/>
          </a:solidFill>
          <a:latin typeface="+mn-lt"/>
          <a:ea typeface="+mn-ea"/>
          <a:cs typeface="+mn-cs"/>
        </a:defRPr>
      </a:lvl2pPr>
      <a:lvl3pPr marL="3359896" algn="l" defTabSz="3359896" rtl="0" eaLnBrk="1" latinLnBrk="0" hangingPunct="1">
        <a:defRPr sz="6608" kern="1200">
          <a:solidFill>
            <a:schemeClr val="tx1"/>
          </a:solidFill>
          <a:latin typeface="+mn-lt"/>
          <a:ea typeface="+mn-ea"/>
          <a:cs typeface="+mn-cs"/>
        </a:defRPr>
      </a:lvl3pPr>
      <a:lvl4pPr marL="5039842" algn="l" defTabSz="3359896" rtl="0" eaLnBrk="1" latinLnBrk="0" hangingPunct="1">
        <a:defRPr sz="6608" kern="1200">
          <a:solidFill>
            <a:schemeClr val="tx1"/>
          </a:solidFill>
          <a:latin typeface="+mn-lt"/>
          <a:ea typeface="+mn-ea"/>
          <a:cs typeface="+mn-cs"/>
        </a:defRPr>
      </a:lvl4pPr>
      <a:lvl5pPr marL="6719789" algn="l" defTabSz="3359896" rtl="0" eaLnBrk="1" latinLnBrk="0" hangingPunct="1">
        <a:defRPr sz="6608" kern="1200">
          <a:solidFill>
            <a:schemeClr val="tx1"/>
          </a:solidFill>
          <a:latin typeface="+mn-lt"/>
          <a:ea typeface="+mn-ea"/>
          <a:cs typeface="+mn-cs"/>
        </a:defRPr>
      </a:lvl5pPr>
      <a:lvl6pPr marL="8399737" algn="l" defTabSz="3359896" rtl="0" eaLnBrk="1" latinLnBrk="0" hangingPunct="1">
        <a:defRPr sz="6608" kern="1200">
          <a:solidFill>
            <a:schemeClr val="tx1"/>
          </a:solidFill>
          <a:latin typeface="+mn-lt"/>
          <a:ea typeface="+mn-ea"/>
          <a:cs typeface="+mn-cs"/>
        </a:defRPr>
      </a:lvl6pPr>
      <a:lvl7pPr marL="10079683" algn="l" defTabSz="3359896" rtl="0" eaLnBrk="1" latinLnBrk="0" hangingPunct="1">
        <a:defRPr sz="6608" kern="1200">
          <a:solidFill>
            <a:schemeClr val="tx1"/>
          </a:solidFill>
          <a:latin typeface="+mn-lt"/>
          <a:ea typeface="+mn-ea"/>
          <a:cs typeface="+mn-cs"/>
        </a:defRPr>
      </a:lvl7pPr>
      <a:lvl8pPr marL="11759632" algn="l" defTabSz="3359896" rtl="0" eaLnBrk="1" latinLnBrk="0" hangingPunct="1">
        <a:defRPr sz="6608" kern="1200">
          <a:solidFill>
            <a:schemeClr val="tx1"/>
          </a:solidFill>
          <a:latin typeface="+mn-lt"/>
          <a:ea typeface="+mn-ea"/>
          <a:cs typeface="+mn-cs"/>
        </a:defRPr>
      </a:lvl8pPr>
      <a:lvl9pPr marL="13439576" algn="l" defTabSz="3359896" rtl="0" eaLnBrk="1" latinLnBrk="0" hangingPunct="1">
        <a:defRPr sz="660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7310153" y="6762991"/>
            <a:ext cx="3727335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RILs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population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(F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/ F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) </a:t>
            </a:r>
          </a:p>
        </p:txBody>
      </p:sp>
      <p:sp>
        <p:nvSpPr>
          <p:cNvPr id="8" name="7 CuadroTexto"/>
          <p:cNvSpPr txBox="1"/>
          <p:nvPr/>
        </p:nvSpPr>
        <p:spPr>
          <a:xfrm>
            <a:off x="12433364" y="3501952"/>
            <a:ext cx="2703779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‘Bola de oro’ (BO) </a:t>
            </a:r>
          </a:p>
        </p:txBody>
      </p:sp>
      <p:cxnSp>
        <p:nvCxnSpPr>
          <p:cNvPr id="13" name="12 Conector recto de flecha"/>
          <p:cNvCxnSpPr/>
          <p:nvPr/>
        </p:nvCxnSpPr>
        <p:spPr>
          <a:xfrm>
            <a:off x="12054564" y="3964850"/>
            <a:ext cx="0" cy="444669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8 CuadroTexto"/>
          <p:cNvSpPr txBox="1"/>
          <p:nvPr/>
        </p:nvSpPr>
        <p:spPr>
          <a:xfrm>
            <a:off x="11792705" y="4413106"/>
            <a:ext cx="578208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F1 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7604116" y="6032485"/>
            <a:ext cx="2458866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to F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/ F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1" name="10 Conector recto de flecha"/>
          <p:cNvCxnSpPr>
            <a:stCxn id="9" idx="2"/>
            <a:endCxn id="10" idx="0"/>
          </p:cNvCxnSpPr>
          <p:nvPr/>
        </p:nvCxnSpPr>
        <p:spPr>
          <a:xfrm flipH="1">
            <a:off x="8833549" y="4888300"/>
            <a:ext cx="3248260" cy="1144184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Grupo 5"/>
          <p:cNvGrpSpPr/>
          <p:nvPr/>
        </p:nvGrpSpPr>
        <p:grpSpPr>
          <a:xfrm>
            <a:off x="10247479" y="5167564"/>
            <a:ext cx="612431" cy="666657"/>
            <a:chOff x="10203041" y="5169955"/>
            <a:chExt cx="612431" cy="666657"/>
          </a:xfrm>
        </p:grpSpPr>
        <p:sp>
          <p:nvSpPr>
            <p:cNvPr id="3" name="2 Elipse"/>
            <p:cNvSpPr/>
            <p:nvPr/>
          </p:nvSpPr>
          <p:spPr>
            <a:xfrm>
              <a:off x="10228420" y="5281946"/>
              <a:ext cx="445208" cy="44467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464"/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10203041" y="5169955"/>
              <a:ext cx="612431" cy="66665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3732" dirty="0">
                  <a:latin typeface="Arial" panose="020B0604020202020204" pitchFamily="34" charset="0"/>
                  <a:cs typeface="Arial" panose="020B0604020202020204" pitchFamily="34" charset="0"/>
                </a:rPr>
                <a:t>X </a:t>
              </a:r>
            </a:p>
          </p:txBody>
        </p:sp>
      </p:grpSp>
      <p:sp>
        <p:nvSpPr>
          <p:cNvPr id="16" name="1 CuadroTexto"/>
          <p:cNvSpPr txBox="1"/>
          <p:nvPr/>
        </p:nvSpPr>
        <p:spPr>
          <a:xfrm>
            <a:off x="8227153" y="8149019"/>
            <a:ext cx="1893335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/ F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7" name="1 CuadroTexto"/>
          <p:cNvSpPr txBox="1"/>
          <p:nvPr/>
        </p:nvSpPr>
        <p:spPr>
          <a:xfrm>
            <a:off x="4076454" y="8012051"/>
            <a:ext cx="3907667" cy="858055"/>
          </a:xfrm>
          <a:prstGeom prst="rect">
            <a:avLst/>
          </a:prstGeom>
          <a:solidFill>
            <a:srgbClr val="F7F9A5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selected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2" name="7 CuadroTexto"/>
          <p:cNvSpPr txBox="1"/>
          <p:nvPr/>
        </p:nvSpPr>
        <p:spPr>
          <a:xfrm>
            <a:off x="10004375" y="3505984"/>
            <a:ext cx="1720247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TGR-1551 </a:t>
            </a:r>
          </a:p>
        </p:txBody>
      </p:sp>
      <p:sp>
        <p:nvSpPr>
          <p:cNvPr id="53" name="7 CuadroTexto"/>
          <p:cNvSpPr txBox="1"/>
          <p:nvPr/>
        </p:nvSpPr>
        <p:spPr>
          <a:xfrm>
            <a:off x="11818786" y="3505987"/>
            <a:ext cx="520414" cy="4751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</a:p>
        </p:txBody>
      </p:sp>
      <p:sp>
        <p:nvSpPr>
          <p:cNvPr id="47" name="8 CuadroTexto"/>
          <p:cNvSpPr txBox="1"/>
          <p:nvPr/>
        </p:nvSpPr>
        <p:spPr>
          <a:xfrm>
            <a:off x="15952299" y="3487907"/>
            <a:ext cx="4872645" cy="4751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Genotyped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sequencing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(GBS)</a:t>
            </a:r>
          </a:p>
        </p:txBody>
      </p:sp>
      <p:sp>
        <p:nvSpPr>
          <p:cNvPr id="69" name="68 CuadroTexto"/>
          <p:cNvSpPr txBox="1"/>
          <p:nvPr/>
        </p:nvSpPr>
        <p:spPr>
          <a:xfrm>
            <a:off x="998034" y="372774"/>
            <a:ext cx="18460775" cy="4751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2488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GB" sz="2488" dirty="0">
                <a:latin typeface="Arial" panose="020B0604020202020204" pitchFamily="34" charset="0"/>
                <a:cs typeface="Arial" panose="020B0604020202020204" pitchFamily="34" charset="0"/>
              </a:rPr>
              <a:t>Generations used and experiments carried out. </a:t>
            </a:r>
          </a:p>
        </p:txBody>
      </p:sp>
      <p:cxnSp>
        <p:nvCxnSpPr>
          <p:cNvPr id="80" name="79 Conector recto de flecha"/>
          <p:cNvCxnSpPr/>
          <p:nvPr/>
        </p:nvCxnSpPr>
        <p:spPr>
          <a:xfrm>
            <a:off x="8809117" y="6556127"/>
            <a:ext cx="0" cy="222335"/>
          </a:xfrm>
          <a:prstGeom prst="straightConnector1">
            <a:avLst/>
          </a:prstGeom>
          <a:ln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9 CuadroTexto"/>
          <p:cNvSpPr txBox="1"/>
          <p:nvPr/>
        </p:nvSpPr>
        <p:spPr>
          <a:xfrm>
            <a:off x="7162142" y="16938490"/>
            <a:ext cx="4023357" cy="4751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Phenotyped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endParaRPr lang="es-ES" sz="24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1 CuadroTexto"/>
          <p:cNvSpPr txBox="1"/>
          <p:nvPr/>
        </p:nvSpPr>
        <p:spPr>
          <a:xfrm>
            <a:off x="9837621" y="7406701"/>
            <a:ext cx="1611814" cy="475195"/>
          </a:xfrm>
          <a:prstGeom prst="rect">
            <a:avLst/>
          </a:prstGeom>
          <a:solidFill>
            <a:srgbClr val="F7F9A5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140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12" name="111 Conector recto de flecha"/>
          <p:cNvCxnSpPr>
            <a:stCxn id="2" idx="2"/>
            <a:endCxn id="16" idx="0"/>
          </p:cNvCxnSpPr>
          <p:nvPr/>
        </p:nvCxnSpPr>
        <p:spPr>
          <a:xfrm>
            <a:off x="9173820" y="7238186"/>
            <a:ext cx="0" cy="910833"/>
          </a:xfrm>
          <a:prstGeom prst="straightConnector1">
            <a:avLst/>
          </a:prstGeom>
          <a:ln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59 Conector recto"/>
          <p:cNvCxnSpPr>
            <a:stCxn id="158" idx="3"/>
            <a:endCxn id="2" idx="1"/>
          </p:cNvCxnSpPr>
          <p:nvPr/>
        </p:nvCxnSpPr>
        <p:spPr>
          <a:xfrm>
            <a:off x="6209414" y="6825075"/>
            <a:ext cx="1100739" cy="1755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6" name="Imagen 7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26" t="24739" r="37901" b="24675"/>
          <a:stretch/>
        </p:blipFill>
        <p:spPr>
          <a:xfrm>
            <a:off x="7075106" y="1359038"/>
            <a:ext cx="1501309" cy="1960042"/>
          </a:xfrm>
          <a:prstGeom prst="rect">
            <a:avLst/>
          </a:prstGeom>
        </p:spPr>
      </p:pic>
      <p:sp>
        <p:nvSpPr>
          <p:cNvPr id="158" name="8 CuadroTexto"/>
          <p:cNvSpPr txBox="1"/>
          <p:nvPr/>
        </p:nvSpPr>
        <p:spPr>
          <a:xfrm>
            <a:off x="853941" y="6396047"/>
            <a:ext cx="5355473" cy="85805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Genotyped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sequencing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(GBS)</a:t>
            </a:r>
          </a:p>
          <a:p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QTLs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endParaRPr lang="es-ES" sz="24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9 CuadroTexto"/>
          <p:cNvSpPr txBox="1"/>
          <p:nvPr/>
        </p:nvSpPr>
        <p:spPr>
          <a:xfrm>
            <a:off x="853941" y="5614097"/>
            <a:ext cx="5358234" cy="4751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Phenotyped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in 5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endParaRPr lang="es-ES" sz="24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57 Abrir llave"/>
          <p:cNvSpPr/>
          <p:nvPr/>
        </p:nvSpPr>
        <p:spPr>
          <a:xfrm flipH="1">
            <a:off x="15588211" y="3461571"/>
            <a:ext cx="249499" cy="554546"/>
          </a:xfrm>
          <a:prstGeom prst="lef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 sz="1464"/>
          </a:p>
        </p:txBody>
      </p:sp>
      <p:sp>
        <p:nvSpPr>
          <p:cNvPr id="167" name="9 CuadroTexto"/>
          <p:cNvSpPr txBox="1"/>
          <p:nvPr/>
        </p:nvSpPr>
        <p:spPr>
          <a:xfrm>
            <a:off x="4220037" y="14202662"/>
            <a:ext cx="4196542" cy="162377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Genotyped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set CYSDV1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Agena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Bioscienc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tform</a:t>
            </a:r>
            <a:endParaRPr lang="es-ES" sz="2488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2488" dirty="0" smtClean="0">
                <a:latin typeface="Arial" panose="020B0604020202020204" pitchFamily="34" charset="0"/>
                <a:cs typeface="Arial" panose="020B0604020202020204" pitchFamily="34" charset="0"/>
              </a:rPr>
              <a:t>QTL </a:t>
            </a:r>
            <a:r>
              <a:rPr lang="es-ES" sz="2488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endParaRPr lang="es-ES" sz="24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9 CuadroTexto"/>
          <p:cNvSpPr txBox="1"/>
          <p:nvPr/>
        </p:nvSpPr>
        <p:spPr>
          <a:xfrm>
            <a:off x="18121520" y="8739182"/>
            <a:ext cx="4872645" cy="4751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Phenotyped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endParaRPr lang="es-ES" sz="24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23" r="18871" b="12066"/>
          <a:stretch/>
        </p:blipFill>
        <p:spPr>
          <a:xfrm>
            <a:off x="12440656" y="1359037"/>
            <a:ext cx="2414319" cy="1960041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09117" y="1359037"/>
            <a:ext cx="2936157" cy="1960041"/>
          </a:xfrm>
          <a:prstGeom prst="rect">
            <a:avLst/>
          </a:prstGeom>
        </p:spPr>
      </p:pic>
      <p:sp>
        <p:nvSpPr>
          <p:cNvPr id="113" name="1 CuadroTexto"/>
          <p:cNvSpPr txBox="1"/>
          <p:nvPr/>
        </p:nvSpPr>
        <p:spPr>
          <a:xfrm>
            <a:off x="13891411" y="10591166"/>
            <a:ext cx="760014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O </a:t>
            </a:r>
          </a:p>
        </p:txBody>
      </p:sp>
      <p:sp>
        <p:nvSpPr>
          <p:cNvPr id="123" name="7 CuadroTexto"/>
          <p:cNvSpPr txBox="1"/>
          <p:nvPr/>
        </p:nvSpPr>
        <p:spPr>
          <a:xfrm>
            <a:off x="13278977" y="10557706"/>
            <a:ext cx="520414" cy="4751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</a:p>
        </p:txBody>
      </p:sp>
      <p:sp>
        <p:nvSpPr>
          <p:cNvPr id="124" name="1 CuadroTexto"/>
          <p:cNvSpPr txBox="1"/>
          <p:nvPr/>
        </p:nvSpPr>
        <p:spPr>
          <a:xfrm>
            <a:off x="10484485" y="10552634"/>
            <a:ext cx="760014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O </a:t>
            </a:r>
          </a:p>
        </p:txBody>
      </p:sp>
      <p:sp>
        <p:nvSpPr>
          <p:cNvPr id="133" name="7 CuadroTexto"/>
          <p:cNvSpPr txBox="1"/>
          <p:nvPr/>
        </p:nvSpPr>
        <p:spPr>
          <a:xfrm>
            <a:off x="9872051" y="10519174"/>
            <a:ext cx="520414" cy="4751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</a:p>
        </p:txBody>
      </p:sp>
      <p:sp>
        <p:nvSpPr>
          <p:cNvPr id="135" name="1 CuadroTexto"/>
          <p:cNvSpPr txBox="1"/>
          <p:nvPr/>
        </p:nvSpPr>
        <p:spPr>
          <a:xfrm>
            <a:off x="6652540" y="10552634"/>
            <a:ext cx="760014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O </a:t>
            </a:r>
          </a:p>
        </p:txBody>
      </p:sp>
      <p:sp>
        <p:nvSpPr>
          <p:cNvPr id="136" name="9 CuadroTexto"/>
          <p:cNvSpPr txBox="1"/>
          <p:nvPr/>
        </p:nvSpPr>
        <p:spPr>
          <a:xfrm>
            <a:off x="5550555" y="12794212"/>
            <a:ext cx="1512200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38" name="9 CuadroTexto"/>
          <p:cNvSpPr txBox="1"/>
          <p:nvPr/>
        </p:nvSpPr>
        <p:spPr>
          <a:xfrm>
            <a:off x="5817725" y="11441971"/>
            <a:ext cx="976735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39" name="10 Conector recto de flecha"/>
          <p:cNvCxnSpPr>
            <a:stCxn id="138" idx="2"/>
            <a:endCxn id="136" idx="0"/>
          </p:cNvCxnSpPr>
          <p:nvPr/>
        </p:nvCxnSpPr>
        <p:spPr>
          <a:xfrm>
            <a:off x="6306093" y="11917166"/>
            <a:ext cx="562" cy="877046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7 CuadroTexto"/>
          <p:cNvSpPr txBox="1"/>
          <p:nvPr/>
        </p:nvSpPr>
        <p:spPr>
          <a:xfrm>
            <a:off x="6040104" y="10519174"/>
            <a:ext cx="520414" cy="4751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</a:p>
        </p:txBody>
      </p:sp>
      <p:sp>
        <p:nvSpPr>
          <p:cNvPr id="146" name="1 CuadroTexto"/>
          <p:cNvSpPr txBox="1"/>
          <p:nvPr/>
        </p:nvSpPr>
        <p:spPr>
          <a:xfrm>
            <a:off x="4708584" y="10552634"/>
            <a:ext cx="1234977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RIL278 </a:t>
            </a:r>
          </a:p>
        </p:txBody>
      </p:sp>
      <p:sp>
        <p:nvSpPr>
          <p:cNvPr id="147" name="1 CuadroTexto"/>
          <p:cNvSpPr txBox="1"/>
          <p:nvPr/>
        </p:nvSpPr>
        <p:spPr>
          <a:xfrm>
            <a:off x="8540528" y="10552634"/>
            <a:ext cx="1237891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RIL556 </a:t>
            </a:r>
          </a:p>
        </p:txBody>
      </p:sp>
      <p:sp>
        <p:nvSpPr>
          <p:cNvPr id="148" name="1 CuadroTexto"/>
          <p:cNvSpPr txBox="1"/>
          <p:nvPr/>
        </p:nvSpPr>
        <p:spPr>
          <a:xfrm>
            <a:off x="12039474" y="10591166"/>
            <a:ext cx="1183928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RIL110 </a:t>
            </a:r>
          </a:p>
        </p:txBody>
      </p:sp>
      <p:cxnSp>
        <p:nvCxnSpPr>
          <p:cNvPr id="54" name="Conector recto 53"/>
          <p:cNvCxnSpPr>
            <a:stCxn id="16" idx="2"/>
            <a:endCxn id="146" idx="0"/>
          </p:cNvCxnSpPr>
          <p:nvPr/>
        </p:nvCxnSpPr>
        <p:spPr>
          <a:xfrm flipH="1">
            <a:off x="5326072" y="8624213"/>
            <a:ext cx="3847748" cy="1928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Conector recto 148"/>
          <p:cNvCxnSpPr>
            <a:stCxn id="16" idx="2"/>
            <a:endCxn id="147" idx="0"/>
          </p:cNvCxnSpPr>
          <p:nvPr/>
        </p:nvCxnSpPr>
        <p:spPr>
          <a:xfrm flipH="1">
            <a:off x="9159474" y="8624213"/>
            <a:ext cx="14347" cy="1928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Conector recto 149"/>
          <p:cNvCxnSpPr>
            <a:stCxn id="16" idx="2"/>
            <a:endCxn id="148" idx="0"/>
          </p:cNvCxnSpPr>
          <p:nvPr/>
        </p:nvCxnSpPr>
        <p:spPr>
          <a:xfrm>
            <a:off x="9173820" y="8624213"/>
            <a:ext cx="3457618" cy="19669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Conector recto de flecha 163"/>
          <p:cNvCxnSpPr>
            <a:stCxn id="144" idx="2"/>
            <a:endCxn id="138" idx="0"/>
          </p:cNvCxnSpPr>
          <p:nvPr/>
        </p:nvCxnSpPr>
        <p:spPr>
          <a:xfrm>
            <a:off x="6300311" y="10994369"/>
            <a:ext cx="5782" cy="447602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59 Conector recto"/>
          <p:cNvCxnSpPr>
            <a:stCxn id="151" idx="3"/>
            <a:endCxn id="2" idx="1"/>
          </p:cNvCxnSpPr>
          <p:nvPr/>
        </p:nvCxnSpPr>
        <p:spPr>
          <a:xfrm>
            <a:off x="6212176" y="5851694"/>
            <a:ext cx="1097977" cy="11488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1 CuadroTexto"/>
          <p:cNvSpPr txBox="1"/>
          <p:nvPr/>
        </p:nvSpPr>
        <p:spPr>
          <a:xfrm>
            <a:off x="828120" y="12615249"/>
            <a:ext cx="3907667" cy="1240917"/>
          </a:xfrm>
          <a:prstGeom prst="rect">
            <a:avLst/>
          </a:prstGeom>
          <a:solidFill>
            <a:srgbClr val="F7F9A5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3 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populations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approximately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130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plants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9" name="9 CuadroTexto"/>
          <p:cNvSpPr txBox="1"/>
          <p:nvPr/>
        </p:nvSpPr>
        <p:spPr>
          <a:xfrm>
            <a:off x="8580376" y="14172663"/>
            <a:ext cx="4778248" cy="162377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Genotyped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set CYSDV1 and CYSDV2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Agena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Bioscienc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tform</a:t>
            </a:r>
            <a:endParaRPr lang="es-ES" sz="2488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2488" dirty="0" smtClean="0">
                <a:latin typeface="Arial" panose="020B0604020202020204" pitchFamily="34" charset="0"/>
                <a:cs typeface="Arial" panose="020B0604020202020204" pitchFamily="34" charset="0"/>
              </a:rPr>
              <a:t>QTL </a:t>
            </a:r>
            <a:r>
              <a:rPr lang="es-ES" sz="2488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endParaRPr lang="es-ES" sz="24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Conector recto 99"/>
          <p:cNvCxnSpPr>
            <a:stCxn id="136" idx="2"/>
            <a:endCxn id="167" idx="0"/>
          </p:cNvCxnSpPr>
          <p:nvPr/>
        </p:nvCxnSpPr>
        <p:spPr>
          <a:xfrm>
            <a:off x="6306655" y="13269407"/>
            <a:ext cx="11653" cy="933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Conector recto 181"/>
          <p:cNvCxnSpPr>
            <a:stCxn id="101" idx="2"/>
            <a:endCxn id="179" idx="0"/>
          </p:cNvCxnSpPr>
          <p:nvPr/>
        </p:nvCxnSpPr>
        <p:spPr>
          <a:xfrm>
            <a:off x="10136990" y="13269407"/>
            <a:ext cx="832510" cy="9032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Abrir llave 110"/>
          <p:cNvSpPr/>
          <p:nvPr/>
        </p:nvSpPr>
        <p:spPr>
          <a:xfrm rot="16200000">
            <a:off x="9074113" y="11304483"/>
            <a:ext cx="459474" cy="1039719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91439" tIns="45719" rIns="91439" bIns="457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s-ES" sz="4551"/>
          </a:p>
        </p:txBody>
      </p:sp>
      <p:sp>
        <p:nvSpPr>
          <p:cNvPr id="230" name="1 CuadroTexto"/>
          <p:cNvSpPr txBox="1"/>
          <p:nvPr/>
        </p:nvSpPr>
        <p:spPr>
          <a:xfrm>
            <a:off x="13252782" y="4460479"/>
            <a:ext cx="760014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O </a:t>
            </a:r>
          </a:p>
        </p:txBody>
      </p:sp>
      <p:sp>
        <p:nvSpPr>
          <p:cNvPr id="232" name="9 CuadroTexto"/>
          <p:cNvSpPr txBox="1"/>
          <p:nvPr/>
        </p:nvSpPr>
        <p:spPr>
          <a:xfrm>
            <a:off x="14014082" y="5730220"/>
            <a:ext cx="976735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37" name="7 CuadroTexto"/>
          <p:cNvSpPr txBox="1"/>
          <p:nvPr/>
        </p:nvSpPr>
        <p:spPr>
          <a:xfrm>
            <a:off x="12640348" y="4427019"/>
            <a:ext cx="520414" cy="4751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</a:p>
        </p:txBody>
      </p:sp>
      <p:cxnSp>
        <p:nvCxnSpPr>
          <p:cNvPr id="238" name="Conector recto de flecha 237"/>
          <p:cNvCxnSpPr>
            <a:stCxn id="237" idx="2"/>
            <a:endCxn id="232" idx="0"/>
          </p:cNvCxnSpPr>
          <p:nvPr/>
        </p:nvCxnSpPr>
        <p:spPr>
          <a:xfrm>
            <a:off x="12900555" y="4902213"/>
            <a:ext cx="1601894" cy="828006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1 CuadroTexto"/>
          <p:cNvSpPr txBox="1"/>
          <p:nvPr/>
        </p:nvSpPr>
        <p:spPr>
          <a:xfrm>
            <a:off x="15837710" y="5745133"/>
            <a:ext cx="760014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O </a:t>
            </a:r>
          </a:p>
        </p:txBody>
      </p:sp>
      <p:sp>
        <p:nvSpPr>
          <p:cNvPr id="240" name="9 CuadroTexto"/>
          <p:cNvSpPr txBox="1"/>
          <p:nvPr/>
        </p:nvSpPr>
        <p:spPr>
          <a:xfrm>
            <a:off x="14972686" y="6634472"/>
            <a:ext cx="976735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41" name="7 CuadroTexto"/>
          <p:cNvSpPr txBox="1"/>
          <p:nvPr/>
        </p:nvSpPr>
        <p:spPr>
          <a:xfrm>
            <a:off x="15225275" y="5711673"/>
            <a:ext cx="520414" cy="4751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</a:p>
        </p:txBody>
      </p:sp>
      <p:cxnSp>
        <p:nvCxnSpPr>
          <p:cNvPr id="242" name="Conector recto de flecha 241"/>
          <p:cNvCxnSpPr>
            <a:stCxn id="241" idx="2"/>
            <a:endCxn id="240" idx="0"/>
          </p:cNvCxnSpPr>
          <p:nvPr/>
        </p:nvCxnSpPr>
        <p:spPr>
          <a:xfrm flipH="1">
            <a:off x="15461054" y="6186867"/>
            <a:ext cx="24429" cy="447604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1 CuadroTexto"/>
          <p:cNvSpPr txBox="1"/>
          <p:nvPr/>
        </p:nvSpPr>
        <p:spPr>
          <a:xfrm>
            <a:off x="16834412" y="6649600"/>
            <a:ext cx="760014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O </a:t>
            </a:r>
          </a:p>
        </p:txBody>
      </p:sp>
      <p:sp>
        <p:nvSpPr>
          <p:cNvPr id="244" name="9 CuadroTexto"/>
          <p:cNvSpPr txBox="1"/>
          <p:nvPr/>
        </p:nvSpPr>
        <p:spPr>
          <a:xfrm>
            <a:off x="15969390" y="7538939"/>
            <a:ext cx="976735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45" name="7 CuadroTexto"/>
          <p:cNvSpPr txBox="1"/>
          <p:nvPr/>
        </p:nvSpPr>
        <p:spPr>
          <a:xfrm>
            <a:off x="16221978" y="6616139"/>
            <a:ext cx="520414" cy="4751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</a:p>
        </p:txBody>
      </p:sp>
      <p:cxnSp>
        <p:nvCxnSpPr>
          <p:cNvPr id="246" name="Conector recto de flecha 245"/>
          <p:cNvCxnSpPr>
            <a:stCxn id="245" idx="2"/>
            <a:endCxn id="244" idx="0"/>
          </p:cNvCxnSpPr>
          <p:nvPr/>
        </p:nvCxnSpPr>
        <p:spPr>
          <a:xfrm flipH="1">
            <a:off x="16457757" y="7091334"/>
            <a:ext cx="24428" cy="447605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1 CuadroTexto"/>
          <p:cNvSpPr txBox="1"/>
          <p:nvPr/>
        </p:nvSpPr>
        <p:spPr>
          <a:xfrm>
            <a:off x="13720232" y="7538937"/>
            <a:ext cx="1836010" cy="475195"/>
          </a:xfrm>
          <a:prstGeom prst="rect">
            <a:avLst/>
          </a:prstGeom>
          <a:solidFill>
            <a:srgbClr val="F7F9A5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plants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75" name="9 CuadroTexto"/>
          <p:cNvSpPr txBox="1"/>
          <p:nvPr/>
        </p:nvSpPr>
        <p:spPr>
          <a:xfrm>
            <a:off x="15692215" y="8951158"/>
            <a:ext cx="1512200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276" name="10 Conector recto de flecha"/>
          <p:cNvCxnSpPr/>
          <p:nvPr/>
        </p:nvCxnSpPr>
        <p:spPr>
          <a:xfrm>
            <a:off x="16447461" y="8043635"/>
            <a:ext cx="0" cy="889343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4" name="9 CuadroTexto"/>
          <p:cNvSpPr txBox="1"/>
          <p:nvPr/>
        </p:nvSpPr>
        <p:spPr>
          <a:xfrm>
            <a:off x="18720667" y="6336035"/>
            <a:ext cx="4872645" cy="200664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Genotyped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Agena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Bioscienc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platform</a:t>
            </a:r>
            <a:endParaRPr lang="es-ES" sz="2488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488" dirty="0">
                <a:latin typeface="Arial" panose="020B0604020202020204" pitchFamily="34" charset="0"/>
                <a:cs typeface="Arial" panose="020B0604020202020204" pitchFamily="34" charset="0"/>
              </a:rPr>
              <a:t>with a set of 124 SNPs evenly distributed throughout the genome </a:t>
            </a:r>
          </a:p>
        </p:txBody>
      </p:sp>
      <p:sp>
        <p:nvSpPr>
          <p:cNvPr id="285" name="9 CuadroTexto"/>
          <p:cNvSpPr txBox="1"/>
          <p:nvPr/>
        </p:nvSpPr>
        <p:spPr>
          <a:xfrm>
            <a:off x="18098647" y="9673272"/>
            <a:ext cx="4778248" cy="12409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Genotyped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set CYSDV1 and CYSDV2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Agena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Bioscience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2488" dirty="0" err="1">
                <a:latin typeface="Arial" panose="020B0604020202020204" pitchFamily="34" charset="0"/>
                <a:cs typeface="Arial" panose="020B0604020202020204" pitchFamily="34" charset="0"/>
              </a:rPr>
              <a:t>platform</a:t>
            </a:r>
            <a:endParaRPr lang="es-ES" sz="24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Conector recto 162"/>
          <p:cNvCxnSpPr>
            <a:stCxn id="275" idx="3"/>
            <a:endCxn id="197" idx="1"/>
          </p:cNvCxnSpPr>
          <p:nvPr/>
        </p:nvCxnSpPr>
        <p:spPr>
          <a:xfrm flipV="1">
            <a:off x="17204415" y="8976779"/>
            <a:ext cx="917104" cy="2119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Conector recto 165"/>
          <p:cNvCxnSpPr>
            <a:stCxn id="275" idx="3"/>
            <a:endCxn id="285" idx="1"/>
          </p:cNvCxnSpPr>
          <p:nvPr/>
        </p:nvCxnSpPr>
        <p:spPr>
          <a:xfrm>
            <a:off x="17204415" y="9188756"/>
            <a:ext cx="894232" cy="11049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6" name="Conector recto 285"/>
          <p:cNvCxnSpPr>
            <a:stCxn id="244" idx="3"/>
            <a:endCxn id="284" idx="1"/>
          </p:cNvCxnSpPr>
          <p:nvPr/>
        </p:nvCxnSpPr>
        <p:spPr>
          <a:xfrm flipV="1">
            <a:off x="16946124" y="7339356"/>
            <a:ext cx="1774542" cy="4371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9 CuadroTexto"/>
          <p:cNvSpPr txBox="1"/>
          <p:nvPr/>
        </p:nvSpPr>
        <p:spPr>
          <a:xfrm>
            <a:off x="9380890" y="12794212"/>
            <a:ext cx="1512200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02" name="9 CuadroTexto"/>
          <p:cNvSpPr txBox="1"/>
          <p:nvPr/>
        </p:nvSpPr>
        <p:spPr>
          <a:xfrm>
            <a:off x="9648060" y="11441971"/>
            <a:ext cx="976735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03" name="10 Conector recto de flecha"/>
          <p:cNvCxnSpPr>
            <a:stCxn id="102" idx="2"/>
            <a:endCxn id="101" idx="0"/>
          </p:cNvCxnSpPr>
          <p:nvPr/>
        </p:nvCxnSpPr>
        <p:spPr>
          <a:xfrm>
            <a:off x="10136428" y="11917166"/>
            <a:ext cx="562" cy="877046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Conector recto de flecha 103"/>
          <p:cNvCxnSpPr>
            <a:endCxn id="102" idx="0"/>
          </p:cNvCxnSpPr>
          <p:nvPr/>
        </p:nvCxnSpPr>
        <p:spPr>
          <a:xfrm>
            <a:off x="10130646" y="10994369"/>
            <a:ext cx="5782" cy="447602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9 CuadroTexto"/>
          <p:cNvSpPr txBox="1"/>
          <p:nvPr/>
        </p:nvSpPr>
        <p:spPr>
          <a:xfrm>
            <a:off x="12799309" y="12794212"/>
            <a:ext cx="1512200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07" name="9 CuadroTexto"/>
          <p:cNvSpPr txBox="1"/>
          <p:nvPr/>
        </p:nvSpPr>
        <p:spPr>
          <a:xfrm>
            <a:off x="13066479" y="11441971"/>
            <a:ext cx="976735" cy="47519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r>
              <a:rPr lang="es-ES" sz="2488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s-ES" sz="248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08" name="10 Conector recto de flecha"/>
          <p:cNvCxnSpPr>
            <a:stCxn id="107" idx="2"/>
            <a:endCxn id="106" idx="0"/>
          </p:cNvCxnSpPr>
          <p:nvPr/>
        </p:nvCxnSpPr>
        <p:spPr>
          <a:xfrm>
            <a:off x="13554847" y="11917166"/>
            <a:ext cx="562" cy="877046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Conector recto de flecha 108"/>
          <p:cNvCxnSpPr>
            <a:endCxn id="107" idx="0"/>
          </p:cNvCxnSpPr>
          <p:nvPr/>
        </p:nvCxnSpPr>
        <p:spPr>
          <a:xfrm>
            <a:off x="13549065" y="10994369"/>
            <a:ext cx="5782" cy="447602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5" name="Grupo 114"/>
          <p:cNvGrpSpPr/>
          <p:nvPr/>
        </p:nvGrpSpPr>
        <p:grpSpPr>
          <a:xfrm>
            <a:off x="6040104" y="12021003"/>
            <a:ext cx="612431" cy="666657"/>
            <a:chOff x="10203041" y="5169955"/>
            <a:chExt cx="612431" cy="666657"/>
          </a:xfrm>
        </p:grpSpPr>
        <p:sp>
          <p:nvSpPr>
            <p:cNvPr id="121" name="2 Elipse"/>
            <p:cNvSpPr/>
            <p:nvPr/>
          </p:nvSpPr>
          <p:spPr>
            <a:xfrm>
              <a:off x="10228420" y="5281946"/>
              <a:ext cx="445208" cy="44467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464"/>
            </a:p>
          </p:txBody>
        </p:sp>
        <p:sp>
          <p:nvSpPr>
            <p:cNvPr id="122" name="14 CuadroTexto"/>
            <p:cNvSpPr txBox="1"/>
            <p:nvPr/>
          </p:nvSpPr>
          <p:spPr>
            <a:xfrm>
              <a:off x="10203041" y="5169955"/>
              <a:ext cx="612431" cy="66665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3732" dirty="0">
                  <a:latin typeface="Arial" panose="020B0604020202020204" pitchFamily="34" charset="0"/>
                  <a:cs typeface="Arial" panose="020B0604020202020204" pitchFamily="34" charset="0"/>
                </a:rPr>
                <a:t>X </a:t>
              </a:r>
            </a:p>
          </p:txBody>
        </p:sp>
      </p:grpSp>
      <p:grpSp>
        <p:nvGrpSpPr>
          <p:cNvPr id="127" name="Grupo 126"/>
          <p:cNvGrpSpPr/>
          <p:nvPr/>
        </p:nvGrpSpPr>
        <p:grpSpPr>
          <a:xfrm>
            <a:off x="9883031" y="12021003"/>
            <a:ext cx="612431" cy="666657"/>
            <a:chOff x="10203041" y="5169955"/>
            <a:chExt cx="612431" cy="666657"/>
          </a:xfrm>
        </p:grpSpPr>
        <p:sp>
          <p:nvSpPr>
            <p:cNvPr id="131" name="2 Elipse"/>
            <p:cNvSpPr/>
            <p:nvPr/>
          </p:nvSpPr>
          <p:spPr>
            <a:xfrm>
              <a:off x="10228420" y="5281946"/>
              <a:ext cx="445208" cy="44467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464"/>
            </a:p>
          </p:txBody>
        </p:sp>
        <p:sp>
          <p:nvSpPr>
            <p:cNvPr id="134" name="14 CuadroTexto"/>
            <p:cNvSpPr txBox="1"/>
            <p:nvPr/>
          </p:nvSpPr>
          <p:spPr>
            <a:xfrm>
              <a:off x="10203041" y="5169955"/>
              <a:ext cx="612431" cy="66665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3732" dirty="0">
                  <a:latin typeface="Arial" panose="020B0604020202020204" pitchFamily="34" charset="0"/>
                  <a:cs typeface="Arial" panose="020B0604020202020204" pitchFamily="34" charset="0"/>
                </a:rPr>
                <a:t>X </a:t>
              </a:r>
            </a:p>
          </p:txBody>
        </p:sp>
      </p:grpSp>
      <p:grpSp>
        <p:nvGrpSpPr>
          <p:cNvPr id="137" name="Grupo 136"/>
          <p:cNvGrpSpPr/>
          <p:nvPr/>
        </p:nvGrpSpPr>
        <p:grpSpPr>
          <a:xfrm>
            <a:off x="13314667" y="12021003"/>
            <a:ext cx="612431" cy="666657"/>
            <a:chOff x="10203041" y="5169955"/>
            <a:chExt cx="612431" cy="666657"/>
          </a:xfrm>
        </p:grpSpPr>
        <p:sp>
          <p:nvSpPr>
            <p:cNvPr id="140" name="2 Elipse"/>
            <p:cNvSpPr/>
            <p:nvPr/>
          </p:nvSpPr>
          <p:spPr>
            <a:xfrm>
              <a:off x="10228420" y="5281946"/>
              <a:ext cx="445208" cy="44467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464"/>
            </a:p>
          </p:txBody>
        </p:sp>
        <p:sp>
          <p:nvSpPr>
            <p:cNvPr id="145" name="14 CuadroTexto"/>
            <p:cNvSpPr txBox="1"/>
            <p:nvPr/>
          </p:nvSpPr>
          <p:spPr>
            <a:xfrm>
              <a:off x="10203041" y="5169955"/>
              <a:ext cx="612431" cy="66665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3732" dirty="0">
                  <a:latin typeface="Arial" panose="020B0604020202020204" pitchFamily="34" charset="0"/>
                  <a:cs typeface="Arial" panose="020B0604020202020204" pitchFamily="34" charset="0"/>
                </a:rPr>
                <a:t>X </a:t>
              </a:r>
            </a:p>
          </p:txBody>
        </p:sp>
      </p:grpSp>
      <p:grpSp>
        <p:nvGrpSpPr>
          <p:cNvPr id="152" name="Grupo 151"/>
          <p:cNvGrpSpPr/>
          <p:nvPr/>
        </p:nvGrpSpPr>
        <p:grpSpPr>
          <a:xfrm>
            <a:off x="16214400" y="8072525"/>
            <a:ext cx="612431" cy="666657"/>
            <a:chOff x="10203041" y="5169955"/>
            <a:chExt cx="612431" cy="666657"/>
          </a:xfrm>
        </p:grpSpPr>
        <p:sp>
          <p:nvSpPr>
            <p:cNvPr id="153" name="2 Elipse"/>
            <p:cNvSpPr/>
            <p:nvPr/>
          </p:nvSpPr>
          <p:spPr>
            <a:xfrm>
              <a:off x="10228420" y="5281946"/>
              <a:ext cx="445208" cy="44467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464"/>
            </a:p>
          </p:txBody>
        </p:sp>
        <p:sp>
          <p:nvSpPr>
            <p:cNvPr id="154" name="14 CuadroTexto"/>
            <p:cNvSpPr txBox="1"/>
            <p:nvPr/>
          </p:nvSpPr>
          <p:spPr>
            <a:xfrm>
              <a:off x="10203041" y="5169955"/>
              <a:ext cx="612431" cy="66665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3732" dirty="0">
                  <a:latin typeface="Arial" panose="020B0604020202020204" pitchFamily="34" charset="0"/>
                  <a:cs typeface="Arial" panose="020B0604020202020204" pitchFamily="34" charset="0"/>
                </a:rPr>
                <a:t>X </a:t>
              </a:r>
            </a:p>
          </p:txBody>
        </p:sp>
      </p:grpSp>
      <p:pic>
        <p:nvPicPr>
          <p:cNvPr id="155" name="Imagen 15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458" r="45284" b="11777"/>
          <a:stretch/>
        </p:blipFill>
        <p:spPr>
          <a:xfrm rot="5400000">
            <a:off x="14864025" y="1567880"/>
            <a:ext cx="1960041" cy="1542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5657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3</TotalTime>
  <Words>170</Words>
  <Application>Microsoft Office PowerPoint</Application>
  <PresentationFormat>Personalizado</PresentationFormat>
  <Paragraphs>5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</dc:creator>
  <cp:lastModifiedBy>...</cp:lastModifiedBy>
  <cp:revision>114</cp:revision>
  <cp:lastPrinted>2018-12-18T09:13:45Z</cp:lastPrinted>
  <dcterms:created xsi:type="dcterms:W3CDTF">2017-08-12T19:15:08Z</dcterms:created>
  <dcterms:modified xsi:type="dcterms:W3CDTF">2020-07-06T10:51:04Z</dcterms:modified>
</cp:coreProperties>
</file>